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0"/>
  </p:normalViewPr>
  <p:slideViewPr>
    <p:cSldViewPr snapToGrid="0">
      <p:cViewPr varScale="1">
        <p:scale>
          <a:sx n="113" d="100"/>
          <a:sy n="113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43A24-3EDE-D7EE-4B0F-89717CC09F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CF3202-3B6C-2CED-C60D-14D41209E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B0109-43FA-37F0-85B9-DC9949D33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BD45DB-85A6-A628-809D-9CC6EC90C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EE7414-6FC4-7D2D-FE11-48E12B0AA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692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E9FDA7-2F08-058E-ADD9-0F2CB6158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73C674-9325-B5AA-3345-D196A2B996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367D39-F601-080F-CA0F-1BB2E1B56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104DB4-26FB-EC9B-E2FF-B7194014A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00E1A-A3EC-C021-5869-275F2D874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54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094282-C543-A031-D09F-CD4E0A8386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67FBA5-3A2B-1CA4-542A-AB8B35446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E3D848-DD57-8E8E-4668-05BF145FA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D0481-3ABE-E6AE-6DBD-125D73AE3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10707B-0E92-1515-BEF4-E56C717FC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706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D54EB-AEA9-88EF-35E3-07805B9F9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2E9FEF-8E3F-BD24-2C7F-85E6B92977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14C18-1808-3F86-ECCF-DEFA60FDF0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825B69-85D8-5195-66B8-ABA81E9B3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6464ED-BCBF-B9FF-301A-B3BCBD6C1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24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63414-B6FB-EC96-BE40-523D2D2F8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28D0A7-65BB-0E38-1D71-837C0E3A5B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8E064-D703-BC27-5A93-A33BAEA0A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74E5AE-D359-3BF3-5731-4355D0F6D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789CAA-1E58-BD8F-3BC5-E58DC817C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024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6AC07E-AF07-3A98-AF05-52CBCCFE9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9F2ACD-76F8-95EA-E55A-0975CD6093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04ECA8-8AD6-EA23-5F9E-7B1AAE60E9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DFE270-7CDB-64BF-747C-62CAABF6F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BC5406-D79E-4645-0242-57275395F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AE9919-A636-2FF6-EE29-A3F21D45F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558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38E25-E5EA-1FDD-2D15-ED88C2C76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7D1ED1-AB3E-3A58-C175-791693A51F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A619E0-B5AC-BDEC-E759-3724BE7735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F635FB-AB18-42B4-E24D-CB5FCCB640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E6BC05-D9EC-14E0-4E76-0D6C5463A5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FCBCB9-3FDE-0CAB-7BC4-191EDAA32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9BCC21-45B8-A6F4-DCEB-E15140052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4F1313-59C8-89B0-E99C-3E411794F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292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7577D-5144-9305-3C48-5DC0CFA53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31674D-3A36-8DBC-44DF-DECAD31F6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C609DB-7480-ED58-771C-036763D8B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4D4531-8A9B-B384-6133-08182113D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7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A60AE4-C626-38B6-08CB-A01DEC082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F00F89-EC68-2F4D-538F-CDBE637D7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D7ED56-9298-573E-C9B6-258DA8128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34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4539C-FC91-0C61-E76E-9C3A3ED984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B40FA9-0A57-145C-D2A0-6294A050FC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49B3DA-993F-89C1-BB14-EEF4A491CB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D3A6FE-1354-C8AA-D138-F45CC3F81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47530-0759-B684-2DC9-89B0132BE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370FD-AFCC-C0E5-ED49-4CF85B99A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122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DA331-EE12-1252-A822-E091DA17C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CCD8BB-DB2C-936E-97D4-FAB8029CEC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E89D8F-D215-B50F-F073-5073417841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F9C2B3-BAF9-43D1-697B-CDF704CD7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6A5F05-689C-EA71-968D-8873F3580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283B72-50F8-357E-3680-682CE8E62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321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CC3114-194E-33EA-70F8-E86C347B91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ADCF4E-D498-90EA-B3D0-9968EA2C3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C4664-5AE5-6997-D600-B8594830E3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23FD49-EB03-FD41-8503-F2E389FDE78A}" type="datetimeFigureOut">
              <a:rPr lang="en-US" smtClean="0"/>
              <a:t>3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EECF59-DDAE-86BA-9D44-9C948D8F9B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BA3A8C-CEA5-5FFE-700E-CD5144A236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63EF24-D051-F140-A843-3257A1AE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851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B30570D3-C1E6-02F4-816E-7FB4EC302165}"/>
              </a:ext>
            </a:extLst>
          </p:cNvPr>
          <p:cNvSpPr/>
          <p:nvPr/>
        </p:nvSpPr>
        <p:spPr>
          <a:xfrm>
            <a:off x="3330606" y="1693415"/>
            <a:ext cx="5530788" cy="34711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FC78645-15B0-E799-F7AB-10E2B136F8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9165582"/>
              </p:ext>
            </p:extLst>
          </p:nvPr>
        </p:nvGraphicFramePr>
        <p:xfrm>
          <a:off x="3505200" y="1097280"/>
          <a:ext cx="5181600" cy="3200400"/>
        </p:xfrm>
        <a:graphic>
          <a:graphicData uri="http://schemas.openxmlformats.org/drawingml/2006/table">
            <a:tbl>
              <a:tblPr/>
              <a:tblGrid>
                <a:gridCol w="5181600">
                  <a:extLst>
                    <a:ext uri="{9D8B030D-6E8A-4147-A177-3AD203B41FA5}">
                      <a16:colId xmlns:a16="http://schemas.microsoft.com/office/drawing/2014/main" val="2710132929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itive Experience Scor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655433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ly Scored Question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08973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device annoyin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60880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experiment borin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95170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experiment mentally tirin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725987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experiment physically tirin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450834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sing the device in the experiment was confusin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183943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itively Scored Question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99193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enjoyed using the devic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51173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elt like I could trust the devic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26544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experiment easy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64619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combined (e.g. diagonal) information from the device easy to interpr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90771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left/right information from the device easy to interpr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36799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 found the up/down information from the device easy to interpr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369414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59D2342-439D-4C90-87CD-45607B2ED5CB}"/>
              </a:ext>
            </a:extLst>
          </p:cNvPr>
          <p:cNvSpPr txBox="1"/>
          <p:nvPr/>
        </p:nvSpPr>
        <p:spPr>
          <a:xfrm>
            <a:off x="2512710" y="4893815"/>
            <a:ext cx="71665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Questions included in the positive experience score. </a:t>
            </a:r>
          </a:p>
          <a:p>
            <a:pPr algn="just"/>
            <a:endParaRPr lang="en-GB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1414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11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Murtough</dc:creator>
  <cp:lastModifiedBy>Spiers, Ad</cp:lastModifiedBy>
  <cp:revision>3</cp:revision>
  <dcterms:created xsi:type="dcterms:W3CDTF">2024-03-11T10:31:39Z</dcterms:created>
  <dcterms:modified xsi:type="dcterms:W3CDTF">2024-03-11T15:33:55Z</dcterms:modified>
</cp:coreProperties>
</file>